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059"/>
    <p:restoredTop sz="94631"/>
  </p:normalViewPr>
  <p:slideViewPr>
    <p:cSldViewPr snapToGrid="0" snapToObjects="1">
      <p:cViewPr>
        <p:scale>
          <a:sx n="92" d="100"/>
          <a:sy n="92" d="100"/>
        </p:scale>
        <p:origin x="1600" y="8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7F0D0D-744B-E34B-A11C-D6F4F09ABC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7106FE0-BA8E-A145-9EAE-32484566B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8E54A5-0DD8-F644-A4EC-7E093ACC8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02FB8A-CD6B-7D45-83C8-3C38D05CD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D0FD22-6B2C-6B4C-9578-C1666027B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004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F8A139-226E-5B4B-8B64-C6E73FD513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67418B-FDF1-F546-80DA-AAB398D28D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16A9A5-487A-004D-A2A0-23FD48C8C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462650-0702-F742-AE4B-6FEDD35CA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926334-FC3C-264A-801B-9B10679C2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2819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4876104-B07C-EB47-8E15-78A2D6E0A9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CEBE56-6311-9B43-BC3C-E4F953FDE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2EF62B-C83B-D844-AD71-4094691B3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C9F58B-B213-7147-8C06-C5D50543C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35D159-E126-314E-8315-5D75D5737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444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2DD039-7EF3-BC44-B266-3176BC4BBB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D3A7DE6-0AA4-4F40-A43D-79342C384F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D2D05A-ED55-6845-AB93-5AA705CA3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8FA28A-71D2-114A-A7EE-473340046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392646-E8CE-214B-A768-DFF4E5E70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96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D6126B-C5FD-A341-90A8-2C482266E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BB9F5D5-7A61-7F4B-AA1E-9E2ED0EF0E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1789929-84AD-8342-91FE-138AEABFD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846666E-6F1B-574C-8726-88E44B253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23978D3-F7EA-8547-88BE-33847054E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376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3A77B9-7BDC-A343-A420-4730191362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4409E08-1ED0-784A-B8CF-B239CCB61C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15D0934-F4AA-DD4E-907F-5313442F4E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184E0C-A9E0-CE43-AE87-458FB2E83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DA7102-F986-0541-9DEC-1F3916DC4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E05A648-8C11-554E-BAB2-32330674E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398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F8FDAE-6A08-484B-8538-7ED199328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6EF457-B38E-0C42-A777-36EDF9436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F3F89D-362D-BF49-8665-FFEE179498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80CC2E9-D2A9-0140-BF6C-793D01949E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82069D-6EE4-8C47-A459-8CAA786EC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4A11BC4-0472-8742-988E-EC8CEBAEC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A20514-4687-414D-9A5E-836284C1B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022B654-B838-8246-8F46-A6B20A47B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648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9950BA-69F9-E445-AB3C-69B485354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6BDA775-575B-664F-BE22-88D2877865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8B48CA-0835-9441-8AC0-AA3224640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730596B-8280-1942-ABEF-FE4CCC62C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037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6A02502-5FDC-FD48-BA1E-673251285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576F1D7-94A6-5948-AED4-BFC46ABC8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3564DDF-4184-8C43-BB16-81BEF6A92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16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4578C1-D9EC-724F-8DFE-F8CD1B442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31B6F09-DAED-CD4F-B720-75D1D2812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C1B6D42-7424-344B-8241-90DB33E77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DA7C881-361D-C245-958A-B687F9694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032EFF0-6FA0-1941-9FB2-9187E8090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AAE75B5-9988-F94D-8F0F-BA115BF90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497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134664-A548-3645-8E8B-0D73A1E09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AA42BCD-6DF7-904E-B21D-5881ADAEEF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95F5F3-05B8-0F43-B62E-8FF42FB3E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A8F895-0AA5-174F-A473-3C4BDFD7D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D47DF81-E2B8-3343-BC88-BBB07B8C2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4E5065-36AD-8244-A973-267FD2B9C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739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F223FBF-ABFE-2B4B-B813-E2E0D0ED5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1A710F8-CF83-084D-B943-F9146D81E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12D2F0-83B6-3C49-9FE3-99B7712384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C6333-9849-F14B-B5E2-7F7102790494}" type="datetimeFigureOut">
              <a:rPr kumimoji="1" lang="ja-JP" altLang="en-US" smtClean="0"/>
              <a:t>2024/3/2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77CC82-B600-2F41-9443-4E7C701236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6E532C-E228-834C-A5CE-E21B10D072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BEAA-3FE7-EB4D-BC87-F1D55E6CF5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981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2A16CFB-2D2C-2A45-9F0B-DF13665A3EF1}"/>
              </a:ext>
            </a:extLst>
          </p:cNvPr>
          <p:cNvSpPr txBox="1"/>
          <p:nvPr/>
        </p:nvSpPr>
        <p:spPr>
          <a:xfrm>
            <a:off x="43374" y="2742124"/>
            <a:ext cx="139465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hase III</a:t>
            </a:r>
          </a:p>
          <a:p>
            <a:pPr algn="ctr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ectable pancreatic ductal carcinom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3D43732-24AE-3A4B-B36A-FBE3698E7C2F}"/>
              </a:ext>
            </a:extLst>
          </p:cNvPr>
          <p:cNvSpPr txBox="1"/>
          <p:nvPr/>
        </p:nvSpPr>
        <p:spPr>
          <a:xfrm>
            <a:off x="287676" y="236306"/>
            <a:ext cx="5414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lliance A02180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DF69AB-6DBB-3B4E-83D7-622828C64E2F}"/>
              </a:ext>
            </a:extLst>
          </p:cNvPr>
          <p:cNvSpPr txBox="1"/>
          <p:nvPr/>
        </p:nvSpPr>
        <p:spPr>
          <a:xfrm>
            <a:off x="1477689" y="1672954"/>
            <a:ext cx="432000" cy="37080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5906557-1E7D-204C-AF09-9872AEE1A300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1909689" y="2504855"/>
            <a:ext cx="54439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0AEB8E8-2FCF-6849-AD08-BB3CE1B02172}"/>
              </a:ext>
            </a:extLst>
          </p:cNvPr>
          <p:cNvCxnSpPr>
            <a:cxnSpLocks/>
            <a:endCxn id="58" idx="1"/>
          </p:cNvCxnSpPr>
          <p:nvPr/>
        </p:nvCxnSpPr>
        <p:spPr>
          <a:xfrm>
            <a:off x="1909689" y="4493646"/>
            <a:ext cx="32249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658F6B3F-67D3-B443-B813-60F04A57F8D8}"/>
              </a:ext>
            </a:extLst>
          </p:cNvPr>
          <p:cNvSpPr txBox="1"/>
          <p:nvPr/>
        </p:nvSpPr>
        <p:spPr>
          <a:xfrm>
            <a:off x="2454083" y="2270855"/>
            <a:ext cx="1202812" cy="468000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B3B6C2-BA42-DE41-9C78-F65ADA01E5C4}"/>
              </a:ext>
            </a:extLst>
          </p:cNvPr>
          <p:cNvSpPr txBox="1"/>
          <p:nvPr/>
        </p:nvSpPr>
        <p:spPr>
          <a:xfrm>
            <a:off x="9068741" y="2042286"/>
            <a:ext cx="2924785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imary outcom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</a:p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econdary outcom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isease-free survival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ime to locoregional recurrenc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ime to distant metastases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0 resection</a:t>
            </a:r>
          </a:p>
          <a:p>
            <a:pPr algn="ctr"/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Unresectability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plete response</a:t>
            </a:r>
          </a:p>
          <a:p>
            <a:pPr algn="ctr"/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ose intensity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dverse event profil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ORTC QLQ-C30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nfluence of diet, BMI, weight loss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T radiomics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F8F5EB0-96EC-B84C-9BA3-573B7A4AE28C}"/>
              </a:ext>
            </a:extLst>
          </p:cNvPr>
          <p:cNvCxnSpPr>
            <a:cxnSpLocks/>
            <a:stCxn id="31" idx="3"/>
            <a:endCxn id="43" idx="1"/>
          </p:cNvCxnSpPr>
          <p:nvPr/>
        </p:nvCxnSpPr>
        <p:spPr>
          <a:xfrm>
            <a:off x="3656895" y="2504855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7629F9F-43DD-5344-B006-4BB474D71D8E}"/>
              </a:ext>
            </a:extLst>
          </p:cNvPr>
          <p:cNvSpPr txBox="1"/>
          <p:nvPr/>
        </p:nvSpPr>
        <p:spPr>
          <a:xfrm>
            <a:off x="8026400" y="2095793"/>
            <a:ext cx="432000" cy="2862322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6C0138-40CA-5149-98A7-5D3D0DC6D0FE}"/>
              </a:ext>
            </a:extLst>
          </p:cNvPr>
          <p:cNvSpPr txBox="1"/>
          <p:nvPr/>
        </p:nvSpPr>
        <p:spPr>
          <a:xfrm>
            <a:off x="4002427" y="2270855"/>
            <a:ext cx="3645282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cycles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7657974A-E3F1-3944-9FA9-281645BB7D9C}"/>
              </a:ext>
            </a:extLst>
          </p:cNvPr>
          <p:cNvCxnSpPr>
            <a:cxnSpLocks/>
          </p:cNvCxnSpPr>
          <p:nvPr/>
        </p:nvCxnSpPr>
        <p:spPr>
          <a:xfrm>
            <a:off x="7647709" y="2504855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953B022A-3E9F-7B48-AC52-34F8444D585E}"/>
              </a:ext>
            </a:extLst>
          </p:cNvPr>
          <p:cNvSpPr txBox="1"/>
          <p:nvPr/>
        </p:nvSpPr>
        <p:spPr>
          <a:xfrm>
            <a:off x="4572359" y="4259646"/>
            <a:ext cx="1202812" cy="468000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DC2AD47-F98B-984E-A66B-48182890E778}"/>
              </a:ext>
            </a:extLst>
          </p:cNvPr>
          <p:cNvSpPr txBox="1"/>
          <p:nvPr/>
        </p:nvSpPr>
        <p:spPr>
          <a:xfrm>
            <a:off x="2232179" y="4259646"/>
            <a:ext cx="2049351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cycle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6636B94-3767-9947-A217-94382103A451}"/>
              </a:ext>
            </a:extLst>
          </p:cNvPr>
          <p:cNvSpPr txBox="1"/>
          <p:nvPr/>
        </p:nvSpPr>
        <p:spPr>
          <a:xfrm>
            <a:off x="6303510" y="4259646"/>
            <a:ext cx="1344199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cycles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67CC6BB-6A25-8140-8BA0-E44F88CB6B19}"/>
              </a:ext>
            </a:extLst>
          </p:cNvPr>
          <p:cNvCxnSpPr>
            <a:cxnSpLocks/>
          </p:cNvCxnSpPr>
          <p:nvPr/>
        </p:nvCxnSpPr>
        <p:spPr>
          <a:xfrm>
            <a:off x="7647709" y="4485339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1FDB4538-5D4F-8343-A922-FB4377E3BD0B}"/>
              </a:ext>
            </a:extLst>
          </p:cNvPr>
          <p:cNvCxnSpPr>
            <a:cxnSpLocks/>
            <a:stCxn id="58" idx="3"/>
          </p:cNvCxnSpPr>
          <p:nvPr/>
        </p:nvCxnSpPr>
        <p:spPr>
          <a:xfrm>
            <a:off x="4281530" y="4493646"/>
            <a:ext cx="29082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BCEAB775-FB22-F346-92C5-1F8180334B41}"/>
              </a:ext>
            </a:extLst>
          </p:cNvPr>
          <p:cNvCxnSpPr>
            <a:cxnSpLocks/>
            <a:stCxn id="57" idx="3"/>
          </p:cNvCxnSpPr>
          <p:nvPr/>
        </p:nvCxnSpPr>
        <p:spPr>
          <a:xfrm>
            <a:off x="5775171" y="4493646"/>
            <a:ext cx="52833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6082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2A16CFB-2D2C-2A45-9F0B-DF13665A3EF1}"/>
              </a:ext>
            </a:extLst>
          </p:cNvPr>
          <p:cNvSpPr txBox="1"/>
          <p:nvPr/>
        </p:nvSpPr>
        <p:spPr>
          <a:xfrm>
            <a:off x="43374" y="2742124"/>
            <a:ext cx="139465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andomized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hase II</a:t>
            </a:r>
          </a:p>
          <a:p>
            <a:pPr algn="ctr"/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ectable pancreatic ductal carcinom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ADF69AB-6DBB-3B4E-83D7-622828C64E2F}"/>
              </a:ext>
            </a:extLst>
          </p:cNvPr>
          <p:cNvSpPr txBox="1"/>
          <p:nvPr/>
        </p:nvSpPr>
        <p:spPr>
          <a:xfrm>
            <a:off x="1477689" y="1672954"/>
            <a:ext cx="432000" cy="37080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5906557-1E7D-204C-AF09-9872AEE1A300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1909689" y="2504855"/>
            <a:ext cx="54439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0AEB8E8-2FCF-6849-AD08-BB3CE1B02172}"/>
              </a:ext>
            </a:extLst>
          </p:cNvPr>
          <p:cNvCxnSpPr>
            <a:cxnSpLocks/>
            <a:endCxn id="58" idx="1"/>
          </p:cNvCxnSpPr>
          <p:nvPr/>
        </p:nvCxnSpPr>
        <p:spPr>
          <a:xfrm>
            <a:off x="1909689" y="4493646"/>
            <a:ext cx="32249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658F6B3F-67D3-B443-B813-60F04A57F8D8}"/>
              </a:ext>
            </a:extLst>
          </p:cNvPr>
          <p:cNvSpPr txBox="1"/>
          <p:nvPr/>
        </p:nvSpPr>
        <p:spPr>
          <a:xfrm>
            <a:off x="2454083" y="2270855"/>
            <a:ext cx="1202812" cy="468000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B3B6C2-BA42-DE41-9C78-F65ADA01E5C4}"/>
              </a:ext>
            </a:extLst>
          </p:cNvPr>
          <p:cNvSpPr txBox="1"/>
          <p:nvPr/>
        </p:nvSpPr>
        <p:spPr>
          <a:xfrm>
            <a:off x="9068741" y="2042286"/>
            <a:ext cx="2924785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imary outcom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 at 12 months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ll therapeutic sequence</a:t>
            </a:r>
          </a:p>
          <a:p>
            <a:pPr algn="ctr"/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econdary outcom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-year disease-free survival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-year overall survival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ORTC QLQ-C30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LQ-PAN26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emotherapy-related toxicity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stsurgical morbidity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ncreatic fistula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istological tumor response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diological tumor response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3F8F5EB0-96EC-B84C-9BA3-573B7A4AE28C}"/>
              </a:ext>
            </a:extLst>
          </p:cNvPr>
          <p:cNvCxnSpPr>
            <a:cxnSpLocks/>
            <a:stCxn id="31" idx="3"/>
            <a:endCxn id="43" idx="1"/>
          </p:cNvCxnSpPr>
          <p:nvPr/>
        </p:nvCxnSpPr>
        <p:spPr>
          <a:xfrm>
            <a:off x="3656895" y="2504855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B7629F9F-43DD-5344-B006-4BB474D71D8E}"/>
              </a:ext>
            </a:extLst>
          </p:cNvPr>
          <p:cNvSpPr txBox="1"/>
          <p:nvPr/>
        </p:nvSpPr>
        <p:spPr>
          <a:xfrm>
            <a:off x="8026400" y="2095793"/>
            <a:ext cx="432000" cy="2862322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  <a:p>
            <a:pPr algn="ctr"/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56C0138-40CA-5149-98A7-5D3D0DC6D0FE}"/>
              </a:ext>
            </a:extLst>
          </p:cNvPr>
          <p:cNvSpPr txBox="1"/>
          <p:nvPr/>
        </p:nvSpPr>
        <p:spPr>
          <a:xfrm>
            <a:off x="4002427" y="2270855"/>
            <a:ext cx="3645282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cycles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7657974A-E3F1-3944-9FA9-281645BB7D9C}"/>
              </a:ext>
            </a:extLst>
          </p:cNvPr>
          <p:cNvCxnSpPr>
            <a:cxnSpLocks/>
          </p:cNvCxnSpPr>
          <p:nvPr/>
        </p:nvCxnSpPr>
        <p:spPr>
          <a:xfrm>
            <a:off x="7647709" y="2504855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953B022A-3E9F-7B48-AC52-34F8444D585E}"/>
              </a:ext>
            </a:extLst>
          </p:cNvPr>
          <p:cNvSpPr txBox="1"/>
          <p:nvPr/>
        </p:nvSpPr>
        <p:spPr>
          <a:xfrm>
            <a:off x="4002427" y="4259646"/>
            <a:ext cx="1204497" cy="468000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DC2AD47-F98B-984E-A66B-48182890E778}"/>
              </a:ext>
            </a:extLst>
          </p:cNvPr>
          <p:cNvSpPr txBox="1"/>
          <p:nvPr/>
        </p:nvSpPr>
        <p:spPr>
          <a:xfrm>
            <a:off x="2232179" y="4259646"/>
            <a:ext cx="1356411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FOX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cycles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67CC6BB-6A25-8140-8BA0-E44F88CB6B19}"/>
              </a:ext>
            </a:extLst>
          </p:cNvPr>
          <p:cNvCxnSpPr>
            <a:cxnSpLocks/>
          </p:cNvCxnSpPr>
          <p:nvPr/>
        </p:nvCxnSpPr>
        <p:spPr>
          <a:xfrm>
            <a:off x="7647709" y="4485339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1FDB4538-5D4F-8343-A922-FB4377E3BD0B}"/>
              </a:ext>
            </a:extLst>
          </p:cNvPr>
          <p:cNvCxnSpPr>
            <a:cxnSpLocks/>
            <a:stCxn id="58" idx="3"/>
          </p:cNvCxnSpPr>
          <p:nvPr/>
        </p:nvCxnSpPr>
        <p:spPr>
          <a:xfrm>
            <a:off x="3588590" y="4493646"/>
            <a:ext cx="41383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BCEAB775-FB22-F346-92C5-1F8180334B41}"/>
              </a:ext>
            </a:extLst>
          </p:cNvPr>
          <p:cNvCxnSpPr>
            <a:cxnSpLocks/>
            <a:stCxn id="57" idx="3"/>
          </p:cNvCxnSpPr>
          <p:nvPr/>
        </p:nvCxnSpPr>
        <p:spPr>
          <a:xfrm flipV="1">
            <a:off x="5206924" y="4485339"/>
            <a:ext cx="528339" cy="83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5F04DF8C-87D7-824A-B97B-F9FE33CA74BB}"/>
              </a:ext>
            </a:extLst>
          </p:cNvPr>
          <p:cNvSpPr txBox="1"/>
          <p:nvPr/>
        </p:nvSpPr>
        <p:spPr>
          <a:xfrm>
            <a:off x="287676" y="236306"/>
            <a:ext cx="5414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PANACE01-PRODIG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A913686E-76E7-0847-880A-C10C48B2A86B}"/>
              </a:ext>
            </a:extLst>
          </p:cNvPr>
          <p:cNvCxnSpPr>
            <a:cxnSpLocks/>
            <a:endCxn id="23" idx="1"/>
          </p:cNvCxnSpPr>
          <p:nvPr/>
        </p:nvCxnSpPr>
        <p:spPr>
          <a:xfrm>
            <a:off x="1909689" y="3490944"/>
            <a:ext cx="3224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48DF5682-8AFD-704D-B5C7-F4C8E3EC8A78}"/>
              </a:ext>
            </a:extLst>
          </p:cNvPr>
          <p:cNvSpPr txBox="1"/>
          <p:nvPr/>
        </p:nvSpPr>
        <p:spPr>
          <a:xfrm>
            <a:off x="4004112" y="3256944"/>
            <a:ext cx="1202812" cy="468000"/>
          </a:xfrm>
          <a:prstGeom prst="rect">
            <a:avLst/>
          </a:prstGeom>
          <a:solidFill>
            <a:schemeClr val="tx1"/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rgery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5AEC92-2360-DE46-85E6-25BC96BA5DB1}"/>
              </a:ext>
            </a:extLst>
          </p:cNvPr>
          <p:cNvSpPr txBox="1"/>
          <p:nvPr/>
        </p:nvSpPr>
        <p:spPr>
          <a:xfrm>
            <a:off x="2232180" y="3256944"/>
            <a:ext cx="1356410" cy="468000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OLFIRINOX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cycle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B53688-E71B-964F-924C-A0A5B189961F}"/>
              </a:ext>
            </a:extLst>
          </p:cNvPr>
          <p:cNvSpPr txBox="1"/>
          <p:nvPr/>
        </p:nvSpPr>
        <p:spPr>
          <a:xfrm>
            <a:off x="5735264" y="3256944"/>
            <a:ext cx="1912446" cy="468000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juvant chemotherapy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 cycles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98BE0D75-9910-5644-B029-A66CAEB36C94}"/>
              </a:ext>
            </a:extLst>
          </p:cNvPr>
          <p:cNvCxnSpPr>
            <a:cxnSpLocks/>
          </p:cNvCxnSpPr>
          <p:nvPr/>
        </p:nvCxnSpPr>
        <p:spPr>
          <a:xfrm>
            <a:off x="7647709" y="3482637"/>
            <a:ext cx="3455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C162D74-4918-1348-B8AF-47AE2FDDAE7E}"/>
              </a:ext>
            </a:extLst>
          </p:cNvPr>
          <p:cNvCxnSpPr>
            <a:cxnSpLocks/>
            <a:stCxn id="23" idx="3"/>
            <a:endCxn id="21" idx="1"/>
          </p:cNvCxnSpPr>
          <p:nvPr/>
        </p:nvCxnSpPr>
        <p:spPr>
          <a:xfrm>
            <a:off x="3588590" y="3490944"/>
            <a:ext cx="41552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85DBC98A-1451-3B45-B996-1E4895C1C124}"/>
              </a:ext>
            </a:extLst>
          </p:cNvPr>
          <p:cNvCxnSpPr>
            <a:cxnSpLocks/>
            <a:stCxn id="21" idx="3"/>
          </p:cNvCxnSpPr>
          <p:nvPr/>
        </p:nvCxnSpPr>
        <p:spPr>
          <a:xfrm>
            <a:off x="5206924" y="3490944"/>
            <a:ext cx="52833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8CEBA65-8482-5C41-B965-42621738DB48}"/>
              </a:ext>
            </a:extLst>
          </p:cNvPr>
          <p:cNvSpPr txBox="1"/>
          <p:nvPr/>
        </p:nvSpPr>
        <p:spPr>
          <a:xfrm>
            <a:off x="5743060" y="4259646"/>
            <a:ext cx="1912446" cy="468000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juvant chemotherapy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 cycles</a:t>
            </a:r>
          </a:p>
        </p:txBody>
      </p:sp>
    </p:spTree>
    <p:extLst>
      <p:ext uri="{BB962C8B-B14F-4D97-AF65-F5344CB8AC3E}">
        <p14:creationId xmlns:p14="http://schemas.microsoft.com/office/powerpoint/2010/main" val="994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7</TotalTime>
  <Words>166</Words>
  <Application>Microsoft Macintosh PowerPoint</Application>
  <PresentationFormat>Widescreen</PresentationFormat>
  <Paragraphs>10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Endo, Yutaka</cp:lastModifiedBy>
  <cp:revision>34</cp:revision>
  <dcterms:created xsi:type="dcterms:W3CDTF">2021-04-06T08:46:24Z</dcterms:created>
  <dcterms:modified xsi:type="dcterms:W3CDTF">2024-03-27T14:10:07Z</dcterms:modified>
</cp:coreProperties>
</file>